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58" r:id="rId3"/>
  </p:sldIdLst>
  <p:sldSz cx="13716000" cy="23774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53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3890859"/>
            <a:ext cx="11658600" cy="8277013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12487065"/>
            <a:ext cx="10287000" cy="5739975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321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221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1265767"/>
            <a:ext cx="2957513" cy="2014770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1265767"/>
            <a:ext cx="8701088" cy="2014770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197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4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5927097"/>
            <a:ext cx="11830050" cy="9889488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15910144"/>
            <a:ext cx="11830050" cy="5200648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/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775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6328834"/>
            <a:ext cx="5829300" cy="1508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6328834"/>
            <a:ext cx="5829300" cy="1508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14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265772"/>
            <a:ext cx="11830050" cy="459528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5828032"/>
            <a:ext cx="5802510" cy="2856228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8684260"/>
            <a:ext cx="5802510" cy="127732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5828032"/>
            <a:ext cx="5831087" cy="2856228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8684260"/>
            <a:ext cx="5831087" cy="127732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43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099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458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584960"/>
            <a:ext cx="4423767" cy="554736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3423079"/>
            <a:ext cx="6943725" cy="16895233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7132320"/>
            <a:ext cx="4423767" cy="13213505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312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584960"/>
            <a:ext cx="4423767" cy="554736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3423079"/>
            <a:ext cx="6943725" cy="16895233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7132320"/>
            <a:ext cx="4423767" cy="13213505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93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1265772"/>
            <a:ext cx="11830050" cy="4595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6328834"/>
            <a:ext cx="11830050" cy="150846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22035352"/>
            <a:ext cx="308610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EEE550-4DA4-4882-B207-893FD3C67A56}" type="datetimeFigureOut">
              <a:rPr lang="en-US" smtClean="0"/>
              <a:t>1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22035352"/>
            <a:ext cx="462915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22035352"/>
            <a:ext cx="308610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A2E15-939C-4E18-AB6C-AE7C8C35C0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427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17EAB95-F63F-16F9-9818-3296F7BD0793}"/>
              </a:ext>
            </a:extLst>
          </p:cNvPr>
          <p:cNvSpPr txBox="1"/>
          <p:nvPr/>
        </p:nvSpPr>
        <p:spPr>
          <a:xfrm>
            <a:off x="2186922" y="1469570"/>
            <a:ext cx="868790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ure S1. </a:t>
            </a:r>
            <a:r>
              <a:rPr lang="en-US" sz="2800" dirty="0"/>
              <a:t>GO enrichment of the differentially expressed proteins in different treatment comparisons of cadmium-treated </a:t>
            </a:r>
            <a:r>
              <a:rPr lang="en-US" sz="2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Rhizoma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</a:t>
            </a:r>
            <a:r>
              <a:rPr lang="en-US" sz="2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Polygonati</a:t>
            </a:r>
            <a:r>
              <a:rPr lang="en-US" sz="2800" dirty="0"/>
              <a:t> 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5028509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4FFB1B8-1950-50B8-A935-EEA15064C180}"/>
              </a:ext>
            </a:extLst>
          </p:cNvPr>
          <p:cNvSpPr txBox="1"/>
          <p:nvPr/>
        </p:nvSpPr>
        <p:spPr>
          <a:xfrm rot="16200000">
            <a:off x="-725215" y="2695431"/>
            <a:ext cx="25426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 vs D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8D327C2-2F73-A061-F112-20EAB6C6C842}"/>
              </a:ext>
            </a:extLst>
          </p:cNvPr>
          <p:cNvSpPr txBox="1"/>
          <p:nvPr/>
        </p:nvSpPr>
        <p:spPr>
          <a:xfrm rot="16200000">
            <a:off x="-725214" y="8769829"/>
            <a:ext cx="25426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 vs D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CBC725-F06F-1775-00F2-542AD767C687}"/>
              </a:ext>
            </a:extLst>
          </p:cNvPr>
          <p:cNvSpPr txBox="1"/>
          <p:nvPr/>
        </p:nvSpPr>
        <p:spPr>
          <a:xfrm rot="16200000">
            <a:off x="-725214" y="14367640"/>
            <a:ext cx="25426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 vs D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E77885-C245-8819-F25D-F5C158931D7D}"/>
              </a:ext>
            </a:extLst>
          </p:cNvPr>
          <p:cNvSpPr txBox="1"/>
          <p:nvPr/>
        </p:nvSpPr>
        <p:spPr>
          <a:xfrm rot="16200000">
            <a:off x="-725214" y="20290410"/>
            <a:ext cx="254268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 vs D5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4FDD44B-DC47-ED0C-90F2-10088884DD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28"/>
          <a:stretch/>
        </p:blipFill>
        <p:spPr>
          <a:xfrm>
            <a:off x="1109295" y="195942"/>
            <a:ext cx="12402015" cy="55977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4752228-0EAC-DA64-0FEB-4783CBE705F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82"/>
          <a:stretch/>
        </p:blipFill>
        <p:spPr>
          <a:xfrm>
            <a:off x="1109295" y="6004256"/>
            <a:ext cx="12402015" cy="5712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8733940-7434-C432-8445-17E8B9E10CC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82"/>
          <a:stretch/>
        </p:blipFill>
        <p:spPr>
          <a:xfrm>
            <a:off x="1109295" y="11927026"/>
            <a:ext cx="12402015" cy="5712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931961C-E1D7-C58F-10FA-6CF7BFCC1B3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82"/>
          <a:stretch/>
        </p:blipFill>
        <p:spPr>
          <a:xfrm>
            <a:off x="1109295" y="17849796"/>
            <a:ext cx="12402015" cy="571222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09950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30</Words>
  <Application>Microsoft Office PowerPoint</Application>
  <PresentationFormat>Custom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s</dc:creator>
  <cp:lastModifiedBy>Authors</cp:lastModifiedBy>
  <cp:revision>5</cp:revision>
  <dcterms:created xsi:type="dcterms:W3CDTF">2022-11-14T09:55:55Z</dcterms:created>
  <dcterms:modified xsi:type="dcterms:W3CDTF">2023-01-11T18:04:10Z</dcterms:modified>
</cp:coreProperties>
</file>